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482" r:id="rId2"/>
    <p:sldId id="401" r:id="rId3"/>
    <p:sldId id="364" r:id="rId4"/>
    <p:sldId id="489" r:id="rId5"/>
    <p:sldId id="490" r:id="rId6"/>
    <p:sldId id="491" r:id="rId7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4" orient="horz" pos="5352" userDrawn="1">
          <p15:clr>
            <a:srgbClr val="A4A3A4"/>
          </p15:clr>
        </p15:guide>
        <p15:guide id="6" pos="640" userDrawn="1">
          <p15:clr>
            <a:srgbClr val="A4A3A4"/>
          </p15:clr>
        </p15:guide>
        <p15:guide id="7" orient="horz" pos="998" userDrawn="1">
          <p15:clr>
            <a:srgbClr val="A4A3A4"/>
          </p15:clr>
        </p15:guide>
        <p15:guide id="9" orient="horz" pos="10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FF"/>
    <a:srgbClr val="00FFFF"/>
    <a:srgbClr val="00FF00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1441F46-9D00-476F-86B4-AE8CE9D54336}" v="24" dt="2026-01-08T00:51:00.61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930" y="-2286"/>
      </p:cViewPr>
      <p:guideLst>
        <p:guide orient="horz" pos="5352"/>
        <p:guide pos="640"/>
        <p:guide orient="horz" pos="998"/>
        <p:guide orient="horz" pos="10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조 두용" userId="511b83a1-bde9-45ea-8923-061d86848069" providerId="ADAL" clId="{3A966524-9B73-44EA-BF8E-C4A3943B7DB3}"/>
    <pc:docChg chg="undo custSel delSld modSld">
      <pc:chgData name="조 두용" userId="511b83a1-bde9-45ea-8923-061d86848069" providerId="ADAL" clId="{3A966524-9B73-44EA-BF8E-C4A3943B7DB3}" dt="2026-01-08T00:51:01.440" v="93" actId="14100"/>
      <pc:docMkLst>
        <pc:docMk/>
      </pc:docMkLst>
      <pc:sldChg chg="del">
        <pc:chgData name="조 두용" userId="511b83a1-bde9-45ea-8923-061d86848069" providerId="ADAL" clId="{3A966524-9B73-44EA-BF8E-C4A3943B7DB3}" dt="2026-01-08T00:44:41.137" v="6" actId="47"/>
        <pc:sldMkLst>
          <pc:docMk/>
          <pc:sldMk cId="1644446635" sldId="260"/>
        </pc:sldMkLst>
      </pc:sldChg>
      <pc:sldChg chg="addSp delSp modSp mod">
        <pc:chgData name="조 두용" userId="511b83a1-bde9-45ea-8923-061d86848069" providerId="ADAL" clId="{3A966524-9B73-44EA-BF8E-C4A3943B7DB3}" dt="2026-01-08T00:50:50.512" v="87"/>
        <pc:sldMkLst>
          <pc:docMk/>
          <pc:sldMk cId="1333128652" sldId="364"/>
        </pc:sldMkLst>
        <pc:spChg chg="add mod">
          <ac:chgData name="조 두용" userId="511b83a1-bde9-45ea-8923-061d86848069" providerId="ADAL" clId="{3A966524-9B73-44EA-BF8E-C4A3943B7DB3}" dt="2026-01-08T00:48:35.719" v="48" actId="113"/>
          <ac:spMkLst>
            <pc:docMk/>
            <pc:sldMk cId="1333128652" sldId="364"/>
            <ac:spMk id="16" creationId="{4E8D830D-ADDE-6CC4-F920-18DA86043D8C}"/>
          </ac:spMkLst>
        </pc:spChg>
        <pc:grpChg chg="del">
          <ac:chgData name="조 두용" userId="511b83a1-bde9-45ea-8923-061d86848069" providerId="ADAL" clId="{3A966524-9B73-44EA-BF8E-C4A3943B7DB3}" dt="2026-01-08T00:50:50.269" v="86" actId="478"/>
          <ac:grpSpMkLst>
            <pc:docMk/>
            <pc:sldMk cId="1333128652" sldId="364"/>
            <ac:grpSpMk id="14" creationId="{00000000-0000-0000-0000-000000000000}"/>
          </ac:grpSpMkLst>
        </pc:grpChg>
        <pc:picChg chg="add del mod">
          <ac:chgData name="조 두용" userId="511b83a1-bde9-45ea-8923-061d86848069" providerId="ADAL" clId="{3A966524-9B73-44EA-BF8E-C4A3943B7DB3}" dt="2026-01-08T00:50:49.191" v="85" actId="21"/>
          <ac:picMkLst>
            <pc:docMk/>
            <pc:sldMk cId="1333128652" sldId="364"/>
            <ac:picMk id="19" creationId="{150C62A7-B935-19C9-209E-CB724B1F257A}"/>
          </ac:picMkLst>
        </pc:picChg>
        <pc:picChg chg="add mod">
          <ac:chgData name="조 두용" userId="511b83a1-bde9-45ea-8923-061d86848069" providerId="ADAL" clId="{3A966524-9B73-44EA-BF8E-C4A3943B7DB3}" dt="2026-01-08T00:50:50.512" v="87"/>
          <ac:picMkLst>
            <pc:docMk/>
            <pc:sldMk cId="1333128652" sldId="364"/>
            <ac:picMk id="40" creationId="{150C62A7-B935-19C9-209E-CB724B1F257A}"/>
          </ac:picMkLst>
        </pc:picChg>
      </pc:sldChg>
      <pc:sldChg chg="del">
        <pc:chgData name="조 두용" userId="511b83a1-bde9-45ea-8923-061d86848069" providerId="ADAL" clId="{3A966524-9B73-44EA-BF8E-C4A3943B7DB3}" dt="2026-01-08T00:44:39.075" v="0" actId="47"/>
        <pc:sldMkLst>
          <pc:docMk/>
          <pc:sldMk cId="3714262642" sldId="380"/>
        </pc:sldMkLst>
      </pc:sldChg>
      <pc:sldChg chg="del">
        <pc:chgData name="조 두용" userId="511b83a1-bde9-45ea-8923-061d86848069" providerId="ADAL" clId="{3A966524-9B73-44EA-BF8E-C4A3943B7DB3}" dt="2026-01-08T00:44:40.065" v="3" actId="47"/>
        <pc:sldMkLst>
          <pc:docMk/>
          <pc:sldMk cId="1754703128" sldId="383"/>
        </pc:sldMkLst>
      </pc:sldChg>
      <pc:sldChg chg="addSp delSp modSp mod">
        <pc:chgData name="조 두용" userId="511b83a1-bde9-45ea-8923-061d86848069" providerId="ADAL" clId="{3A966524-9B73-44EA-BF8E-C4A3943B7DB3}" dt="2026-01-08T00:50:44.173" v="82"/>
        <pc:sldMkLst>
          <pc:docMk/>
          <pc:sldMk cId="2101325197" sldId="401"/>
        </pc:sldMkLst>
        <pc:spChg chg="add mod">
          <ac:chgData name="조 두용" userId="511b83a1-bde9-45ea-8923-061d86848069" providerId="ADAL" clId="{3A966524-9B73-44EA-BF8E-C4A3943B7DB3}" dt="2026-01-08T00:48:14.777" v="41" actId="113"/>
          <ac:spMkLst>
            <pc:docMk/>
            <pc:sldMk cId="2101325197" sldId="401"/>
            <ac:spMk id="2" creationId="{D882006E-F186-840A-4889-CD25EB72B6E3}"/>
          </ac:spMkLst>
        </pc:spChg>
        <pc:grpChg chg="del">
          <ac:chgData name="조 두용" userId="511b83a1-bde9-45ea-8923-061d86848069" providerId="ADAL" clId="{3A966524-9B73-44EA-BF8E-C4A3943B7DB3}" dt="2026-01-08T00:50:43.870" v="81" actId="478"/>
          <ac:grpSpMkLst>
            <pc:docMk/>
            <pc:sldMk cId="2101325197" sldId="401"/>
            <ac:grpSpMk id="3" creationId="{0DF429DB-4675-42B0-98D9-F897627D6C3D}"/>
          </ac:grpSpMkLst>
        </pc:grpChg>
        <pc:picChg chg="add del mod">
          <ac:chgData name="조 두용" userId="511b83a1-bde9-45ea-8923-061d86848069" providerId="ADAL" clId="{3A966524-9B73-44EA-BF8E-C4A3943B7DB3}" dt="2026-01-08T00:50:43.044" v="80" actId="21"/>
          <ac:picMkLst>
            <pc:docMk/>
            <pc:sldMk cId="2101325197" sldId="401"/>
            <ac:picMk id="5" creationId="{FD247034-A9F8-627A-1708-E627D22E16CC}"/>
          </ac:picMkLst>
        </pc:picChg>
        <pc:picChg chg="add mod">
          <ac:chgData name="조 두용" userId="511b83a1-bde9-45ea-8923-061d86848069" providerId="ADAL" clId="{3A966524-9B73-44EA-BF8E-C4A3943B7DB3}" dt="2026-01-08T00:50:44.173" v="82"/>
          <ac:picMkLst>
            <pc:docMk/>
            <pc:sldMk cId="2101325197" sldId="401"/>
            <ac:picMk id="6" creationId="{FD247034-A9F8-627A-1708-E627D22E16CC}"/>
          </ac:picMkLst>
        </pc:picChg>
      </pc:sldChg>
      <pc:sldChg chg="del">
        <pc:chgData name="조 두용" userId="511b83a1-bde9-45ea-8923-061d86848069" providerId="ADAL" clId="{3A966524-9B73-44EA-BF8E-C4A3943B7DB3}" dt="2026-01-08T00:44:39.693" v="2" actId="47"/>
        <pc:sldMkLst>
          <pc:docMk/>
          <pc:sldMk cId="3209593694" sldId="468"/>
        </pc:sldMkLst>
      </pc:sldChg>
      <pc:sldChg chg="del">
        <pc:chgData name="조 두용" userId="511b83a1-bde9-45ea-8923-061d86848069" providerId="ADAL" clId="{3A966524-9B73-44EA-BF8E-C4A3943B7DB3}" dt="2026-01-08T00:44:40.313" v="4" actId="47"/>
        <pc:sldMkLst>
          <pc:docMk/>
          <pc:sldMk cId="1598186273" sldId="471"/>
        </pc:sldMkLst>
      </pc:sldChg>
      <pc:sldChg chg="del">
        <pc:chgData name="조 두용" userId="511b83a1-bde9-45ea-8923-061d86848069" providerId="ADAL" clId="{3A966524-9B73-44EA-BF8E-C4A3943B7DB3}" dt="2026-01-08T00:44:41.575" v="7" actId="47"/>
        <pc:sldMkLst>
          <pc:docMk/>
          <pc:sldMk cId="976147336" sldId="485"/>
        </pc:sldMkLst>
      </pc:sldChg>
      <pc:sldChg chg="del">
        <pc:chgData name="조 두용" userId="511b83a1-bde9-45ea-8923-061d86848069" providerId="ADAL" clId="{3A966524-9B73-44EA-BF8E-C4A3943B7DB3}" dt="2026-01-08T00:44:40.772" v="5" actId="47"/>
        <pc:sldMkLst>
          <pc:docMk/>
          <pc:sldMk cId="2596776995" sldId="488"/>
        </pc:sldMkLst>
      </pc:sldChg>
      <pc:sldChg chg="addSp delSp modSp mod">
        <pc:chgData name="조 두용" userId="511b83a1-bde9-45ea-8923-061d86848069" providerId="ADAL" clId="{3A966524-9B73-44EA-BF8E-C4A3943B7DB3}" dt="2026-01-08T00:51:01.440" v="93" actId="14100"/>
        <pc:sldMkLst>
          <pc:docMk/>
          <pc:sldMk cId="2056429893" sldId="489"/>
        </pc:sldMkLst>
        <pc:spChg chg="add mod">
          <ac:chgData name="조 두용" userId="511b83a1-bde9-45ea-8923-061d86848069" providerId="ADAL" clId="{3A966524-9B73-44EA-BF8E-C4A3943B7DB3}" dt="2026-01-08T00:49:13.336" v="55" actId="113"/>
          <ac:spMkLst>
            <pc:docMk/>
            <pc:sldMk cId="2056429893" sldId="489"/>
            <ac:spMk id="2" creationId="{93DE967D-0FA8-18B0-929F-38C705244DCB}"/>
          </ac:spMkLst>
        </pc:spChg>
        <pc:spChg chg="add">
          <ac:chgData name="조 두용" userId="511b83a1-bde9-45ea-8923-061d86848069" providerId="ADAL" clId="{3A966524-9B73-44EA-BF8E-C4A3943B7DB3}" dt="2026-01-08T00:48:52.499" v="49"/>
          <ac:spMkLst>
            <pc:docMk/>
            <pc:sldMk cId="2056429893" sldId="489"/>
            <ac:spMk id="4" creationId="{A196ED3E-E13F-A298-242F-4C4A515506AD}"/>
          </ac:spMkLst>
        </pc:spChg>
        <pc:spChg chg="add">
          <ac:chgData name="조 두용" userId="511b83a1-bde9-45ea-8923-061d86848069" providerId="ADAL" clId="{3A966524-9B73-44EA-BF8E-C4A3943B7DB3}" dt="2026-01-08T00:48:52.499" v="49"/>
          <ac:spMkLst>
            <pc:docMk/>
            <pc:sldMk cId="2056429893" sldId="489"/>
            <ac:spMk id="5" creationId="{03D30DFA-52C6-555E-01D8-0F4B39C2A5A2}"/>
          </ac:spMkLst>
        </pc:spChg>
        <pc:spChg chg="add">
          <ac:chgData name="조 두용" userId="511b83a1-bde9-45ea-8923-061d86848069" providerId="ADAL" clId="{3A966524-9B73-44EA-BF8E-C4A3943B7DB3}" dt="2026-01-08T00:48:57.106" v="50"/>
          <ac:spMkLst>
            <pc:docMk/>
            <pc:sldMk cId="2056429893" sldId="489"/>
            <ac:spMk id="6" creationId="{C110C4F9-AEB4-91ED-8825-5468BAF8E03E}"/>
          </ac:spMkLst>
        </pc:spChg>
        <pc:spChg chg="add">
          <ac:chgData name="조 두용" userId="511b83a1-bde9-45ea-8923-061d86848069" providerId="ADAL" clId="{3A966524-9B73-44EA-BF8E-C4A3943B7DB3}" dt="2026-01-08T00:48:57.106" v="50"/>
          <ac:spMkLst>
            <pc:docMk/>
            <pc:sldMk cId="2056429893" sldId="489"/>
            <ac:spMk id="7" creationId="{2307DCA3-AB9F-299B-1700-BD8E046C99F8}"/>
          </ac:spMkLst>
        </pc:spChg>
        <pc:grpChg chg="del">
          <ac:chgData name="조 두용" userId="511b83a1-bde9-45ea-8923-061d86848069" providerId="ADAL" clId="{3A966524-9B73-44EA-BF8E-C4A3943B7DB3}" dt="2026-01-08T00:51:00.404" v="91" actId="478"/>
          <ac:grpSpMkLst>
            <pc:docMk/>
            <pc:sldMk cId="2056429893" sldId="489"/>
            <ac:grpSpMk id="3" creationId="{28962164-9878-EA9D-28E4-653DC659BF87}"/>
          </ac:grpSpMkLst>
        </pc:grpChg>
        <pc:picChg chg="add del mod">
          <ac:chgData name="조 두용" userId="511b83a1-bde9-45ea-8923-061d86848069" providerId="ADAL" clId="{3A966524-9B73-44EA-BF8E-C4A3943B7DB3}" dt="2026-01-08T00:50:58.852" v="90" actId="21"/>
          <ac:picMkLst>
            <pc:docMk/>
            <pc:sldMk cId="2056429893" sldId="489"/>
            <ac:picMk id="9" creationId="{63941EAC-CCE2-A2BC-A646-DA5A5F4063B0}"/>
          </ac:picMkLst>
        </pc:picChg>
        <pc:picChg chg="add mod">
          <ac:chgData name="조 두용" userId="511b83a1-bde9-45ea-8923-061d86848069" providerId="ADAL" clId="{3A966524-9B73-44EA-BF8E-C4A3943B7DB3}" dt="2026-01-08T00:51:01.440" v="93" actId="14100"/>
          <ac:picMkLst>
            <pc:docMk/>
            <pc:sldMk cId="2056429893" sldId="489"/>
            <ac:picMk id="10" creationId="{63941EAC-CCE2-A2BC-A646-DA5A5F4063B0}"/>
          </ac:picMkLst>
        </pc:picChg>
        <pc:picChg chg="add">
          <ac:chgData name="조 두용" userId="511b83a1-bde9-45ea-8923-061d86848069" providerId="ADAL" clId="{3A966524-9B73-44EA-BF8E-C4A3943B7DB3}" dt="2026-01-08T00:48:52.499" v="49"/>
          <ac:picMkLst>
            <pc:docMk/>
            <pc:sldMk cId="2056429893" sldId="489"/>
            <ac:picMk id="1025" creationId="{AE995C71-1764-70DF-F85A-3D6C2B843B73}"/>
          </ac:picMkLst>
        </pc:picChg>
        <pc:picChg chg="add">
          <ac:chgData name="조 두용" userId="511b83a1-bde9-45ea-8923-061d86848069" providerId="ADAL" clId="{3A966524-9B73-44EA-BF8E-C4A3943B7DB3}" dt="2026-01-08T00:48:57.106" v="50"/>
          <ac:picMkLst>
            <pc:docMk/>
            <pc:sldMk cId="2056429893" sldId="489"/>
            <ac:picMk id="1028" creationId="{32FEF42F-2C8B-AAC1-1CD7-1A19F56F9446}"/>
          </ac:picMkLst>
        </pc:picChg>
      </pc:sldChg>
      <pc:sldChg chg="addSp delSp modSp mod">
        <pc:chgData name="조 두용" userId="511b83a1-bde9-45ea-8923-061d86848069" providerId="ADAL" clId="{3A966524-9B73-44EA-BF8E-C4A3943B7DB3}" dt="2026-01-08T00:48:18.898" v="42" actId="113"/>
        <pc:sldMkLst>
          <pc:docMk/>
          <pc:sldMk cId="1912469919" sldId="490"/>
        </pc:sldMkLst>
        <pc:spChg chg="add mod">
          <ac:chgData name="조 두용" userId="511b83a1-bde9-45ea-8923-061d86848069" providerId="ADAL" clId="{3A966524-9B73-44EA-BF8E-C4A3943B7DB3}" dt="2026-01-08T00:48:18.898" v="42" actId="113"/>
          <ac:spMkLst>
            <pc:docMk/>
            <pc:sldMk cId="1912469919" sldId="490"/>
            <ac:spMk id="72" creationId="{9AE04BFA-2D0C-1CB2-FD57-4EC368BE9FC8}"/>
          </ac:spMkLst>
        </pc:spChg>
        <pc:grpChg chg="del">
          <ac:chgData name="조 두용" userId="511b83a1-bde9-45ea-8923-061d86848069" providerId="ADAL" clId="{3A966524-9B73-44EA-BF8E-C4A3943B7DB3}" dt="2026-01-08T00:46:13.140" v="32" actId="478"/>
          <ac:grpSpMkLst>
            <pc:docMk/>
            <pc:sldMk cId="1912469919" sldId="490"/>
            <ac:grpSpMk id="71" creationId="{AFC1CADD-3D7E-D68C-71B9-BE0877D6BD73}"/>
          </ac:grpSpMkLst>
        </pc:grpChg>
        <pc:picChg chg="add mod">
          <ac:chgData name="조 두용" userId="511b83a1-bde9-45ea-8923-061d86848069" providerId="ADAL" clId="{3A966524-9B73-44EA-BF8E-C4A3943B7DB3}" dt="2026-01-08T00:44:54.136" v="9"/>
          <ac:picMkLst>
            <pc:docMk/>
            <pc:sldMk cId="1912469919" sldId="490"/>
            <ac:picMk id="55" creationId="{DF202637-D054-6830-93E9-A18AFF9C5FA7}"/>
          </ac:picMkLst>
        </pc:picChg>
        <pc:picChg chg="add mod">
          <ac:chgData name="조 두용" userId="511b83a1-bde9-45ea-8923-061d86848069" providerId="ADAL" clId="{3A966524-9B73-44EA-BF8E-C4A3943B7DB3}" dt="2026-01-08T00:45:33.416" v="28"/>
          <ac:picMkLst>
            <pc:docMk/>
            <pc:sldMk cId="1912469919" sldId="490"/>
            <ac:picMk id="74" creationId="{9FF30C64-21A4-6DF2-5508-0FF6F2C21334}"/>
          </ac:picMkLst>
        </pc:picChg>
        <pc:picChg chg="add del mod">
          <ac:chgData name="조 두용" userId="511b83a1-bde9-45ea-8923-061d86848069" providerId="ADAL" clId="{3A966524-9B73-44EA-BF8E-C4A3943B7DB3}" dt="2026-01-08T00:46:12.104" v="31" actId="21"/>
          <ac:picMkLst>
            <pc:docMk/>
            <pc:sldMk cId="1912469919" sldId="490"/>
            <ac:picMk id="76" creationId="{C15FC6E5-DA99-7C40-BD00-B549C66037D6}"/>
          </ac:picMkLst>
        </pc:picChg>
        <pc:picChg chg="add mod">
          <ac:chgData name="조 두용" userId="511b83a1-bde9-45ea-8923-061d86848069" providerId="ADAL" clId="{3A966524-9B73-44EA-BF8E-C4A3943B7DB3}" dt="2026-01-08T00:46:13.427" v="33"/>
          <ac:picMkLst>
            <pc:docMk/>
            <pc:sldMk cId="1912469919" sldId="490"/>
            <ac:picMk id="77" creationId="{C15FC6E5-DA99-7C40-BD00-B549C66037D6}"/>
          </ac:picMkLst>
        </pc:picChg>
      </pc:sldChg>
      <pc:sldChg chg="del">
        <pc:chgData name="조 두용" userId="511b83a1-bde9-45ea-8923-061d86848069" providerId="ADAL" clId="{3A966524-9B73-44EA-BF8E-C4A3943B7DB3}" dt="2026-01-08T00:44:39.339" v="1" actId="47"/>
        <pc:sldMkLst>
          <pc:docMk/>
          <pc:sldMk cId="2034410941" sldId="491"/>
        </pc:sldMkLst>
      </pc:sldChg>
    </pc:docChg>
  </pc:docChgLst>
  <pc:docChgLst>
    <pc:chgData name="조 두용" userId="511b83a1-bde9-45ea-8923-061d86848069" providerId="ADAL" clId="{80E02EBB-374C-4A09-8616-A5009EB9357D}"/>
    <pc:docChg chg="undo custSel modSld">
      <pc:chgData name="조 두용" userId="511b83a1-bde9-45ea-8923-061d86848069" providerId="ADAL" clId="{80E02EBB-374C-4A09-8616-A5009EB9357D}" dt="2026-01-06T04:16:02.806" v="9" actId="478"/>
      <pc:docMkLst>
        <pc:docMk/>
      </pc:docMkLst>
      <pc:sldChg chg="delSp mod">
        <pc:chgData name="조 두용" userId="511b83a1-bde9-45ea-8923-061d86848069" providerId="ADAL" clId="{80E02EBB-374C-4A09-8616-A5009EB9357D}" dt="2026-01-06T04:07:32.054" v="3" actId="478"/>
        <pc:sldMkLst>
          <pc:docMk/>
          <pc:sldMk cId="1333128652" sldId="364"/>
        </pc:sldMkLst>
      </pc:sldChg>
      <pc:sldChg chg="delSp mod">
        <pc:chgData name="조 두용" userId="511b83a1-bde9-45ea-8923-061d86848069" providerId="ADAL" clId="{80E02EBB-374C-4A09-8616-A5009EB9357D}" dt="2026-01-06T04:06:57.307" v="2" actId="478"/>
        <pc:sldMkLst>
          <pc:docMk/>
          <pc:sldMk cId="2101325197" sldId="401"/>
        </pc:sldMkLst>
      </pc:sldChg>
      <pc:sldChg chg="delSp mod">
        <pc:chgData name="조 두용" userId="511b83a1-bde9-45ea-8923-061d86848069" providerId="ADAL" clId="{80E02EBB-374C-4A09-8616-A5009EB9357D}" dt="2026-01-06T04:07:57.882" v="4" actId="478"/>
        <pc:sldMkLst>
          <pc:docMk/>
          <pc:sldMk cId="2056429893" sldId="489"/>
        </pc:sldMkLst>
      </pc:sldChg>
      <pc:sldChg chg="delSp mod">
        <pc:chgData name="조 두용" userId="511b83a1-bde9-45ea-8923-061d86848069" providerId="ADAL" clId="{80E02EBB-374C-4A09-8616-A5009EB9357D}" dt="2026-01-06T04:08:14.120" v="5" actId="478"/>
        <pc:sldMkLst>
          <pc:docMk/>
          <pc:sldMk cId="1912469919" sldId="49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BD6EE6-3A40-4FCE-A2B5-6E73E19F59F2}" type="datetimeFigureOut">
              <a:rPr lang="ko-KR" altLang="en-US" smtClean="0"/>
              <a:t>2026-03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B25D5C-3FF9-4027-81FF-C1D8E93C6F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72904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A3D0F-30A8-48E9-8473-D8B3EE294EBC}" type="datetimeFigureOut">
              <a:rPr lang="ko-KR" altLang="en-US" smtClean="0"/>
              <a:t>2026-03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5C8F4-C0E4-48A2-B9AA-C5659F487C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2255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A3D0F-30A8-48E9-8473-D8B3EE294EBC}" type="datetimeFigureOut">
              <a:rPr lang="ko-KR" altLang="en-US" smtClean="0"/>
              <a:t>2026-03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5C8F4-C0E4-48A2-B9AA-C5659F487C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3413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A3D0F-30A8-48E9-8473-D8B3EE294EBC}" type="datetimeFigureOut">
              <a:rPr lang="ko-KR" altLang="en-US" smtClean="0"/>
              <a:t>2026-03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5C8F4-C0E4-48A2-B9AA-C5659F487C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3307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A3D0F-30A8-48E9-8473-D8B3EE294EBC}" type="datetimeFigureOut">
              <a:rPr lang="ko-KR" altLang="en-US" smtClean="0"/>
              <a:t>2026-03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5C8F4-C0E4-48A2-B9AA-C5659F487C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4424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A3D0F-30A8-48E9-8473-D8B3EE294EBC}" type="datetimeFigureOut">
              <a:rPr lang="ko-KR" altLang="en-US" smtClean="0"/>
              <a:t>2026-03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5C8F4-C0E4-48A2-B9AA-C5659F487C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5945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A3D0F-30A8-48E9-8473-D8B3EE294EBC}" type="datetimeFigureOut">
              <a:rPr lang="ko-KR" altLang="en-US" smtClean="0"/>
              <a:t>2026-03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5C8F4-C0E4-48A2-B9AA-C5659F487C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9360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A3D0F-30A8-48E9-8473-D8B3EE294EBC}" type="datetimeFigureOut">
              <a:rPr lang="ko-KR" altLang="en-US" smtClean="0"/>
              <a:t>2026-03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5C8F4-C0E4-48A2-B9AA-C5659F487C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0512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A3D0F-30A8-48E9-8473-D8B3EE294EBC}" type="datetimeFigureOut">
              <a:rPr lang="ko-KR" altLang="en-US" smtClean="0"/>
              <a:t>2026-03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5C8F4-C0E4-48A2-B9AA-C5659F487C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1857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A3D0F-30A8-48E9-8473-D8B3EE294EBC}" type="datetimeFigureOut">
              <a:rPr lang="ko-KR" altLang="en-US" smtClean="0"/>
              <a:t>2026-03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5C8F4-C0E4-48A2-B9AA-C5659F487C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9031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A3D0F-30A8-48E9-8473-D8B3EE294EBC}" type="datetimeFigureOut">
              <a:rPr lang="ko-KR" altLang="en-US" smtClean="0"/>
              <a:t>2026-03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5C8F4-C0E4-48A2-B9AA-C5659F487C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6583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A3D0F-30A8-48E9-8473-D8B3EE294EBC}" type="datetimeFigureOut">
              <a:rPr lang="ko-KR" altLang="en-US" smtClean="0"/>
              <a:t>2026-03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5C8F4-C0E4-48A2-B9AA-C5659F487C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0131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A3D0F-30A8-48E9-8473-D8B3EE294EBC}" type="datetimeFigureOut">
              <a:rPr lang="ko-KR" altLang="en-US" smtClean="0"/>
              <a:t>2026-03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5C8F4-C0E4-48A2-B9AA-C5659F487C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9911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sv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sv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15E981BE-58F6-404B-B7C0-B245B54223B3}"/>
              </a:ext>
            </a:extLst>
          </p:cNvPr>
          <p:cNvSpPr/>
          <p:nvPr/>
        </p:nvSpPr>
        <p:spPr>
          <a:xfrm>
            <a:off x="1690270" y="3960374"/>
            <a:ext cx="3926075" cy="5078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700" b="1">
                <a:latin typeface="Times New Roman" panose="02020603050405020304" pitchFamily="18" charset="0"/>
              </a:rPr>
              <a:t>Supplementary materials</a:t>
            </a:r>
            <a:endParaRPr lang="ko-KR" altLang="en-US" sz="2700"/>
          </a:p>
        </p:txBody>
      </p:sp>
    </p:spTree>
    <p:extLst>
      <p:ext uri="{BB962C8B-B14F-4D97-AF65-F5344CB8AC3E}">
        <p14:creationId xmlns:p14="http://schemas.microsoft.com/office/powerpoint/2010/main" val="17635522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882006E-F186-840A-4889-CD25EB72B6E3}"/>
              </a:ext>
            </a:extLst>
          </p:cNvPr>
          <p:cNvSpPr txBox="1"/>
          <p:nvPr/>
        </p:nvSpPr>
        <p:spPr>
          <a:xfrm>
            <a:off x="370405" y="6756747"/>
            <a:ext cx="6117188" cy="20928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ko-KR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Figure S1.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Typical UPLC chromatograms of 13 isoflavone derivatives and chemical structures. (A) Typical UPLC chromatograms of 13 isoflavone derivatives and (B) chemical structures of 13 isoflavone derivatives. Peak 1. 2’-hydroxy genistein-4’,7-</a:t>
            </a:r>
            <a:r>
              <a:rPr lang="en-US" altLang="ko-KR" sz="11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O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-diglucoside (HGDG); 2. 2’-hydroxy, 5-methoxy genistein-7-</a:t>
            </a:r>
            <a:r>
              <a:rPr lang="en-US" altLang="ko-KR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O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-glucoside (HMGG); 3. 2’-hydroxy genistein-7-</a:t>
            </a:r>
            <a:r>
              <a:rPr lang="en-US" altLang="ko-KR" sz="11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O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-gentibioside (HGGB); 4. 5-methoxy genistein-7-</a:t>
            </a:r>
            <a:r>
              <a:rPr lang="en-US" altLang="ko-KR" sz="11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O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-glucoside (MGG); 5. 2’-hydroxy genistein-7-</a:t>
            </a:r>
            <a:r>
              <a:rPr lang="en-US" altLang="ko-KR" sz="11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O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-glucoside (HG7G); 6. genistein-7-</a:t>
            </a:r>
            <a:r>
              <a:rPr lang="en-US" altLang="ko-KR" sz="11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O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-gentibioside (GGB); 7. 2’-hydroxy genistein-4’-</a:t>
            </a:r>
            <a:r>
              <a:rPr lang="en-US" altLang="ko-KR" sz="11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O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-glucoside (HG4G); 8. </a:t>
            </a:r>
            <a:r>
              <a:rPr lang="en-US" altLang="ko-KR" sz="11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genistin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 (GEI); 9. </a:t>
            </a:r>
            <a:r>
              <a:rPr lang="en-US" altLang="ko-KR" sz="11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barpisoflavone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 A (BIA); 10. 4’,7-dihydroxy-5-methoxyisoflavone (DHMI); 11. </a:t>
            </a:r>
            <a:r>
              <a:rPr lang="en-US" altLang="ko-KR" sz="11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gerontoisoflavone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 A (GIA); 12. 2’-hydroxygenistein (HGE); and 13. genistein (GEE).</a:t>
            </a:r>
            <a:endParaRPr lang="ko-KR" altLang="ko-KR" sz="9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4" name="그래픽 3">
            <a:extLst>
              <a:ext uri="{FF2B5EF4-FFF2-40B4-BE49-F238E27FC236}">
                <a16:creationId xmlns:a16="http://schemas.microsoft.com/office/drawing/2014/main" id="{19F40A58-3CE0-7535-9B30-E907E46FF7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95116" y="1673955"/>
            <a:ext cx="5667768" cy="46626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13251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4E8D830D-ADDE-6CC4-F920-18DA86043D8C}"/>
              </a:ext>
            </a:extLst>
          </p:cNvPr>
          <p:cNvSpPr txBox="1"/>
          <p:nvPr/>
        </p:nvSpPr>
        <p:spPr>
          <a:xfrm>
            <a:off x="370405" y="7446066"/>
            <a:ext cx="6117188" cy="569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altLang="ko-KR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Figure S2.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Lactic acid </a:t>
            </a:r>
            <a:r>
              <a:rPr lang="en-US" altLang="ko-KR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fermentation process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of AAM by the cockatiel </a:t>
            </a:r>
            <a:r>
              <a:rPr lang="en-US" altLang="ko-KR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L. plantarum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LAB02 and </a:t>
            </a:r>
            <a:r>
              <a:rPr lang="en-US" altLang="ko-KR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L. brevis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BMK484</a:t>
            </a:r>
            <a:endParaRPr lang="ko-KR" altLang="ko-KR" sz="9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3" name="그래픽 2">
            <a:extLst>
              <a:ext uri="{FF2B5EF4-FFF2-40B4-BE49-F238E27FC236}">
                <a16:creationId xmlns:a16="http://schemas.microsoft.com/office/drawing/2014/main" id="{C2E5F0F5-8B04-175E-36A3-E3E58FFD55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95116" y="3191496"/>
            <a:ext cx="5667768" cy="2761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31286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3DE967D-0FA8-18B0-929F-38C705244DCB}"/>
              </a:ext>
            </a:extLst>
          </p:cNvPr>
          <p:cNvSpPr txBox="1"/>
          <p:nvPr/>
        </p:nvSpPr>
        <p:spPr>
          <a:xfrm>
            <a:off x="370405" y="7446066"/>
            <a:ext cx="6117188" cy="3158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ko-KR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 Figure S3.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Nucleotide sequence of 16S rRNA from </a:t>
            </a:r>
            <a:r>
              <a:rPr lang="en-US" altLang="ko-KR" sz="11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L. brevis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LAB02.</a:t>
            </a:r>
          </a:p>
        </p:txBody>
      </p:sp>
      <p:pic>
        <p:nvPicPr>
          <p:cNvPr id="4" name="그래픽 3">
            <a:extLst>
              <a:ext uri="{FF2B5EF4-FFF2-40B4-BE49-F238E27FC236}">
                <a16:creationId xmlns:a16="http://schemas.microsoft.com/office/drawing/2014/main" id="{9B12D489-A4B6-AF14-A85D-33C9C954BAC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95116" y="2575703"/>
            <a:ext cx="5667768" cy="39925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64298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71">
            <a:extLst>
              <a:ext uri="{FF2B5EF4-FFF2-40B4-BE49-F238E27FC236}">
                <a16:creationId xmlns:a16="http://schemas.microsoft.com/office/drawing/2014/main" id="{9AE04BFA-2D0C-1CB2-FD57-4EC368BE9FC8}"/>
              </a:ext>
            </a:extLst>
          </p:cNvPr>
          <p:cNvSpPr txBox="1"/>
          <p:nvPr/>
        </p:nvSpPr>
        <p:spPr>
          <a:xfrm>
            <a:off x="370405" y="7446066"/>
            <a:ext cx="6117188" cy="8232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ko-KR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Figure S4.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Phylogenetic placement by 16S rRNA sequences of </a:t>
            </a:r>
            <a:r>
              <a:rPr lang="en-US" altLang="ko-KR" sz="11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L. brevis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strain LAB02. Number above each node are confidence levels (%) generated from 1,000 </a:t>
            </a:r>
            <a:r>
              <a:rPr lang="en-US" altLang="ko-KR" sz="11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bootrap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 trees. The scale bar is in fixed nucleotide substitutions per sequences position.</a:t>
            </a:r>
            <a:endParaRPr lang="ko-KR" altLang="ko-KR" sz="9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3" name="그래픽 2">
            <a:extLst>
              <a:ext uri="{FF2B5EF4-FFF2-40B4-BE49-F238E27FC236}">
                <a16:creationId xmlns:a16="http://schemas.microsoft.com/office/drawing/2014/main" id="{C306CCB8-E565-C816-8577-E77AE0291C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95116" y="1990426"/>
            <a:ext cx="5667768" cy="51631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24699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CFC74D1-419A-D690-C11C-20A3B1AC4D4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71">
            <a:extLst>
              <a:ext uri="{FF2B5EF4-FFF2-40B4-BE49-F238E27FC236}">
                <a16:creationId xmlns:a16="http://schemas.microsoft.com/office/drawing/2014/main" id="{92B195B3-D550-1F02-F926-F79995C1257D}"/>
              </a:ext>
            </a:extLst>
          </p:cNvPr>
          <p:cNvSpPr txBox="1"/>
          <p:nvPr/>
        </p:nvSpPr>
        <p:spPr>
          <a:xfrm>
            <a:off x="370405" y="6981831"/>
            <a:ext cx="6117188" cy="18389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altLang="ko-KR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Figure S5.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Comparison of minerals in AAM during food processing stages. (A) score plot of principal component analysis and (B) correlation heatmap analysis. Food processing stages: DrAAM, dried </a:t>
            </a:r>
            <a:r>
              <a:rPr lang="en-US" altLang="ko-KR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Apios americana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 </a:t>
            </a:r>
            <a:r>
              <a:rPr lang="en-US" altLang="ko-KR" sz="11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Medikus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; </a:t>
            </a:r>
            <a:r>
              <a:rPr lang="en-US" altLang="ko-KR" sz="11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StAAM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, sterilized </a:t>
            </a:r>
            <a:r>
              <a:rPr lang="en-US" altLang="ko-KR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Apios americana </a:t>
            </a:r>
            <a:r>
              <a:rPr lang="en-US" altLang="ko-KR" sz="11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Medikus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; </a:t>
            </a:r>
            <a:r>
              <a:rPr lang="en-US" altLang="ko-KR" sz="11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FeAAM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, fermented </a:t>
            </a:r>
            <a:r>
              <a:rPr lang="en-US" altLang="ko-KR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Apios americana </a:t>
            </a:r>
            <a:r>
              <a:rPr lang="en-US" altLang="ko-KR" sz="11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Medikus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. AAM was fermented at 30°C for 36 h using the cockatiel </a:t>
            </a:r>
            <a:r>
              <a:rPr lang="en-US" altLang="ko-KR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L. plantarum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LAB02 and </a:t>
            </a:r>
            <a:r>
              <a:rPr lang="en-US" altLang="ko-KR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L. brevis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BMK484 (1:1). Values of the various conditions were normalized and clustered in the heatmap. The color displays the intensity of the normalized mean values of different parameters. The value of </a:t>
            </a:r>
            <a:r>
              <a:rPr lang="en-US" altLang="ko-KR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p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휴먼명조"/>
                <a:cs typeface="Times New Roman" panose="02020603050405020304" pitchFamily="18" charset="0"/>
              </a:rPr>
              <a:t> &lt; 0.05 was used to determine as statistically significant difference.</a:t>
            </a:r>
            <a:endParaRPr lang="ko-KR" altLang="ko-KR" sz="9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3" name="그래픽 2">
            <a:extLst>
              <a:ext uri="{FF2B5EF4-FFF2-40B4-BE49-F238E27FC236}">
                <a16:creationId xmlns:a16="http://schemas.microsoft.com/office/drawing/2014/main" id="{043B8297-9341-A88C-DDF2-3424218E43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95116" y="3512240"/>
            <a:ext cx="5667768" cy="21195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60437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테마">
  <a:themeElements>
    <a:clrScheme name="Office 2013 - 2022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9</TotalTime>
  <Words>345</Words>
  <Application>Microsoft Office PowerPoint</Application>
  <PresentationFormat>화면 슬라이드 쇼(4:3)</PresentationFormat>
  <Paragraphs>6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Times New Roman</vt:lpstr>
      <vt:lpstr>Office 2013 - 2022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.M.Jo</dc:creator>
  <cp:lastModifiedBy>희율 이</cp:lastModifiedBy>
  <cp:revision>4</cp:revision>
  <dcterms:created xsi:type="dcterms:W3CDTF">2023-05-10T07:29:47Z</dcterms:created>
  <dcterms:modified xsi:type="dcterms:W3CDTF">2026-03-11T06:55:04Z</dcterms:modified>
</cp:coreProperties>
</file>